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00800" cy="8231188"/>
  <p:notesSz cx="6858000" cy="9144000"/>
  <p:defaultTextStyle>
    <a:defPPr>
      <a:defRPr lang="en-US"/>
    </a:defPPr>
    <a:lvl1pPr marL="0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77795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55588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33382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511175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888970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266763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644557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022350" algn="l" defTabSz="755588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2112" y="-114"/>
      </p:cViewPr>
      <p:guideLst>
        <p:guide orient="horz" pos="2594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1" y="2557005"/>
            <a:ext cx="5440680" cy="1764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60122" y="4664339"/>
            <a:ext cx="4480561" cy="210352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77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555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333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111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889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667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44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022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4814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7542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90287" y="213402"/>
            <a:ext cx="710089" cy="45538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798" y="213402"/>
            <a:ext cx="2025809" cy="45538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4002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4277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5619" y="5289302"/>
            <a:ext cx="5440680" cy="1634805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5619" y="3488729"/>
            <a:ext cx="5440680" cy="1800573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7779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5558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3338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111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888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2667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6445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0223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12757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798" y="1246111"/>
            <a:ext cx="1367949" cy="3521120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32427" y="1246111"/>
            <a:ext cx="1367949" cy="3521120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9479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9631"/>
            <a:ext cx="5760721" cy="137186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842493"/>
            <a:ext cx="2828132" cy="767863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7795" indent="0">
              <a:buNone/>
              <a:defRPr sz="1600" b="1"/>
            </a:lvl2pPr>
            <a:lvl3pPr marL="755588" indent="0">
              <a:buNone/>
              <a:defRPr sz="1500" b="1"/>
            </a:lvl3pPr>
            <a:lvl4pPr marL="1133382" indent="0">
              <a:buNone/>
              <a:defRPr sz="1300" b="1"/>
            </a:lvl4pPr>
            <a:lvl5pPr marL="1511175" indent="0">
              <a:buNone/>
              <a:defRPr sz="1300" b="1"/>
            </a:lvl5pPr>
            <a:lvl6pPr marL="1888970" indent="0">
              <a:buNone/>
              <a:defRPr sz="1300" b="1"/>
            </a:lvl6pPr>
            <a:lvl7pPr marL="2266763" indent="0">
              <a:buNone/>
              <a:defRPr sz="1300" b="1"/>
            </a:lvl7pPr>
            <a:lvl8pPr marL="2644557" indent="0">
              <a:buNone/>
              <a:defRPr sz="1300" b="1"/>
            </a:lvl8pPr>
            <a:lvl9pPr marL="3022350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040" y="2610356"/>
            <a:ext cx="2828132" cy="474246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51520" y="1842493"/>
            <a:ext cx="2829242" cy="767863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77795" indent="0">
              <a:buNone/>
              <a:defRPr sz="1600" b="1"/>
            </a:lvl2pPr>
            <a:lvl3pPr marL="755588" indent="0">
              <a:buNone/>
              <a:defRPr sz="1500" b="1"/>
            </a:lvl3pPr>
            <a:lvl4pPr marL="1133382" indent="0">
              <a:buNone/>
              <a:defRPr sz="1300" b="1"/>
            </a:lvl4pPr>
            <a:lvl5pPr marL="1511175" indent="0">
              <a:buNone/>
              <a:defRPr sz="1300" b="1"/>
            </a:lvl5pPr>
            <a:lvl6pPr marL="1888970" indent="0">
              <a:buNone/>
              <a:defRPr sz="1300" b="1"/>
            </a:lvl6pPr>
            <a:lvl7pPr marL="2266763" indent="0">
              <a:buNone/>
              <a:defRPr sz="1300" b="1"/>
            </a:lvl7pPr>
            <a:lvl8pPr marL="2644557" indent="0">
              <a:buNone/>
              <a:defRPr sz="1300" b="1"/>
            </a:lvl8pPr>
            <a:lvl9pPr marL="3022350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51520" y="2610356"/>
            <a:ext cx="2829242" cy="474246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990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9368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6704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0040" y="327724"/>
            <a:ext cx="2105819" cy="1394730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2534" y="327724"/>
            <a:ext cx="3578225" cy="7025092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0040" y="1722453"/>
            <a:ext cx="2105819" cy="5630362"/>
          </a:xfrm>
        </p:spPr>
        <p:txBody>
          <a:bodyPr/>
          <a:lstStyle>
            <a:lvl1pPr marL="0" indent="0">
              <a:buNone/>
              <a:defRPr sz="1200"/>
            </a:lvl1pPr>
            <a:lvl2pPr marL="377795" indent="0">
              <a:buNone/>
              <a:defRPr sz="1000"/>
            </a:lvl2pPr>
            <a:lvl3pPr marL="755588" indent="0">
              <a:buNone/>
              <a:defRPr sz="900"/>
            </a:lvl3pPr>
            <a:lvl4pPr marL="1133382" indent="0">
              <a:buNone/>
              <a:defRPr sz="700"/>
            </a:lvl4pPr>
            <a:lvl5pPr marL="1511175" indent="0">
              <a:buNone/>
              <a:defRPr sz="700"/>
            </a:lvl5pPr>
            <a:lvl6pPr marL="1888970" indent="0">
              <a:buNone/>
              <a:defRPr sz="700"/>
            </a:lvl6pPr>
            <a:lvl7pPr marL="2266763" indent="0">
              <a:buNone/>
              <a:defRPr sz="700"/>
            </a:lvl7pPr>
            <a:lvl8pPr marL="2644557" indent="0">
              <a:buNone/>
              <a:defRPr sz="700"/>
            </a:lvl8pPr>
            <a:lvl9pPr marL="302235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17296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4604" y="5761832"/>
            <a:ext cx="3840480" cy="680217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54604" y="735474"/>
            <a:ext cx="3840480" cy="4938713"/>
          </a:xfrm>
        </p:spPr>
        <p:txBody>
          <a:bodyPr/>
          <a:lstStyle>
            <a:lvl1pPr marL="0" indent="0">
              <a:buNone/>
              <a:defRPr sz="2700"/>
            </a:lvl1pPr>
            <a:lvl2pPr marL="377795" indent="0">
              <a:buNone/>
              <a:defRPr sz="2400"/>
            </a:lvl2pPr>
            <a:lvl3pPr marL="755588" indent="0">
              <a:buNone/>
              <a:defRPr sz="1900"/>
            </a:lvl3pPr>
            <a:lvl4pPr marL="1133382" indent="0">
              <a:buNone/>
              <a:defRPr sz="1600"/>
            </a:lvl4pPr>
            <a:lvl5pPr marL="1511175" indent="0">
              <a:buNone/>
              <a:defRPr sz="1600"/>
            </a:lvl5pPr>
            <a:lvl6pPr marL="1888970" indent="0">
              <a:buNone/>
              <a:defRPr sz="1600"/>
            </a:lvl6pPr>
            <a:lvl7pPr marL="2266763" indent="0">
              <a:buNone/>
              <a:defRPr sz="1600"/>
            </a:lvl7pPr>
            <a:lvl8pPr marL="2644557" indent="0">
              <a:buNone/>
              <a:defRPr sz="1600"/>
            </a:lvl8pPr>
            <a:lvl9pPr marL="3022350" indent="0">
              <a:buNone/>
              <a:defRPr sz="16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4604" y="6442048"/>
            <a:ext cx="3840480" cy="966021"/>
          </a:xfrm>
        </p:spPr>
        <p:txBody>
          <a:bodyPr/>
          <a:lstStyle>
            <a:lvl1pPr marL="0" indent="0">
              <a:buNone/>
              <a:defRPr sz="1200"/>
            </a:lvl1pPr>
            <a:lvl2pPr marL="377795" indent="0">
              <a:buNone/>
              <a:defRPr sz="1000"/>
            </a:lvl2pPr>
            <a:lvl3pPr marL="755588" indent="0">
              <a:buNone/>
              <a:defRPr sz="900"/>
            </a:lvl3pPr>
            <a:lvl4pPr marL="1133382" indent="0">
              <a:buNone/>
              <a:defRPr sz="700"/>
            </a:lvl4pPr>
            <a:lvl5pPr marL="1511175" indent="0">
              <a:buNone/>
              <a:defRPr sz="700"/>
            </a:lvl5pPr>
            <a:lvl6pPr marL="1888970" indent="0">
              <a:buNone/>
              <a:defRPr sz="700"/>
            </a:lvl6pPr>
            <a:lvl7pPr marL="2266763" indent="0">
              <a:buNone/>
              <a:defRPr sz="700"/>
            </a:lvl7pPr>
            <a:lvl8pPr marL="2644557" indent="0">
              <a:buNone/>
              <a:defRPr sz="700"/>
            </a:lvl8pPr>
            <a:lvl9pPr marL="302235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89753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0040" y="329631"/>
            <a:ext cx="5760721" cy="1371865"/>
          </a:xfrm>
          <a:prstGeom prst="rect">
            <a:avLst/>
          </a:prstGeom>
        </p:spPr>
        <p:txBody>
          <a:bodyPr vert="horz" lIns="75559" tIns="37779" rIns="75559" bIns="3777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0040" y="1920611"/>
            <a:ext cx="5760721" cy="5432204"/>
          </a:xfrm>
          <a:prstGeom prst="rect">
            <a:avLst/>
          </a:prstGeom>
        </p:spPr>
        <p:txBody>
          <a:bodyPr vert="horz" lIns="75559" tIns="37779" rIns="75559" bIns="3777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0040" y="7629091"/>
            <a:ext cx="1493520" cy="438235"/>
          </a:xfrm>
          <a:prstGeom prst="rect">
            <a:avLst/>
          </a:prstGeom>
        </p:spPr>
        <p:txBody>
          <a:bodyPr vert="horz" lIns="75559" tIns="37779" rIns="75559" bIns="37779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29FD5-D5A5-40E7-B171-D807FA6CE5F8}" type="datetimeFigureOut">
              <a:rPr lang="en-CA" smtClean="0"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86942" y="7629091"/>
            <a:ext cx="2026920" cy="438235"/>
          </a:xfrm>
          <a:prstGeom prst="rect">
            <a:avLst/>
          </a:prstGeom>
        </p:spPr>
        <p:txBody>
          <a:bodyPr vert="horz" lIns="75559" tIns="37779" rIns="75559" bIns="37779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7240" y="7629091"/>
            <a:ext cx="1493520" cy="438235"/>
          </a:xfrm>
          <a:prstGeom prst="rect">
            <a:avLst/>
          </a:prstGeom>
        </p:spPr>
        <p:txBody>
          <a:bodyPr vert="horz" lIns="75559" tIns="37779" rIns="75559" bIns="37779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CF693-33E4-4033-ABCD-9472D03955A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74979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55588" rtl="0" eaLnBrk="1" latinLnBrk="0" hangingPunct="1">
        <a:spcBef>
          <a:spcPct val="0"/>
        </a:spcBef>
        <a:buNone/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3345" indent="-283345" algn="l" defTabSz="75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13914" indent="-236121" algn="l" defTabSz="755588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44484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322279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700073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77866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55661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33454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11248" indent="-188897" algn="l" defTabSz="75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77795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55588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33382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11175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8970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66763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44557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22350" algn="l" defTabSz="755588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5500244"/>
              </p:ext>
            </p:extLst>
          </p:nvPr>
        </p:nvGraphicFramePr>
        <p:xfrm>
          <a:off x="-6" y="21"/>
          <a:ext cx="6400805" cy="8231166"/>
        </p:xfrm>
        <a:graphic>
          <a:graphicData uri="http://schemas.openxmlformats.org/drawingml/2006/table">
            <a:tbl>
              <a:tblPr/>
              <a:tblGrid>
                <a:gridCol w="1606202"/>
                <a:gridCol w="587845"/>
                <a:gridCol w="504797"/>
                <a:gridCol w="504797"/>
                <a:gridCol w="504797"/>
                <a:gridCol w="504797"/>
                <a:gridCol w="470102"/>
                <a:gridCol w="787173"/>
                <a:gridCol w="930295"/>
              </a:tblGrid>
              <a:tr h="40661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te Type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gnitude Difference 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gnitude Difference 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3475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Response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on-Walled Beache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lam Garden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x time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% increase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0661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ariable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an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an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E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CG/NWB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([CG/NWB*100]-100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06617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ensity (count/0.270m</a:t>
                      </a:r>
                      <a:r>
                        <a:rPr lang="en-CA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All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7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3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5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. giganteu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2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. philippinarum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1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1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coma spp.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9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2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3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LL clam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1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9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81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47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1-13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5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14-26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7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27-39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40-52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7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(53-65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1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06617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Biomass (kg/0.270m</a:t>
                      </a:r>
                      <a:r>
                        <a:rPr lang="en-CA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</a:t>
                      </a:r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. staminea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5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27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76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5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6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. giganteu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4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3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33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0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5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5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. philippinarum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9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9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9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coma spp.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2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5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3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3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LL clams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.43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8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0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.02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5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7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06617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s                           (((L</a:t>
                      </a:r>
                      <a:r>
                        <a:rPr lang="en-CA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f</a:t>
                      </a:r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L</a:t>
                      </a:r>
                      <a:r>
                        <a:rPr lang="en-CA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</a:t>
                      </a:r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/L</a:t>
                      </a:r>
                      <a:r>
                        <a:rPr lang="en-CA" sz="1000" b="1" i="0" u="none" strike="noStrike" baseline="-2500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</a:t>
                      </a:r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)/160days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All sizes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4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1-16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7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7-22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2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23-28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2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06617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All sizes) (excluding WB10,WB31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9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628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1-16mm) (excluding WB10,WB31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.3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628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17-22mm) (excluding WB10,WB31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6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628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owth rate (23-28mm) (excluding WB10,WB31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3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6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06617">
                <a:tc>
                  <a:txBody>
                    <a:bodyPr/>
                    <a:lstStyle/>
                    <a:p>
                      <a:pPr algn="l" fontAlgn="ctr"/>
                      <a:r>
                        <a:rPr lang="en-CA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al (survivorship/160days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All sizes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7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11-16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4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12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8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3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17-22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6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70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.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4457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urvivorship (23-28mm)</a:t>
                      </a:r>
                    </a:p>
                  </a:txBody>
                  <a:tcPr marL="6601" marR="6601" marT="66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84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7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7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0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0.91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9</a:t>
                      </a:r>
                    </a:p>
                  </a:txBody>
                  <a:tcPr marL="6601" marR="6601" marT="660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838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408</Words>
  <Application>Microsoft Office PowerPoint</Application>
  <PresentationFormat>Custom</PresentationFormat>
  <Paragraphs>29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imon Fraser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y</dc:creator>
  <cp:lastModifiedBy>Amy</cp:lastModifiedBy>
  <cp:revision>9</cp:revision>
  <dcterms:created xsi:type="dcterms:W3CDTF">2013-08-20T18:47:52Z</dcterms:created>
  <dcterms:modified xsi:type="dcterms:W3CDTF">2013-09-17T19:29:59Z</dcterms:modified>
</cp:coreProperties>
</file>